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88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C4F2BD-5EE7-1341-827C-747C1ADCC5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66308B-E7D2-E4D6-A707-2F7DC08AB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0F5494-9E6E-9717-F7B9-57543472C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0D1AA0-7305-8838-E9DA-6A007F854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F15D58-B258-C157-A07C-56C2BCE11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93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36FFC1-9348-E172-4A96-2549886D2E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3F539B-8493-B4DE-EDD3-49008E3DB4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098E6C-B588-0543-ADFD-B2AD6BF4D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C0B715-3EA9-CDA2-49E4-8C28F21B9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3D280B-1B9C-6681-0A0A-0E28461AA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592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68515A-CB62-196D-AA91-AB36E4CB6C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AD4C71-832F-B05A-636E-8DBB2584D2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D568E0-7FF0-E1A4-D45A-6BBECF194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3C0734-22AE-A725-2B38-BD384CB3E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E3783-3668-94A5-EDEF-C0BC3407D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286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5A54B0-F604-BFEB-A5E0-A5883A375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2E354E-D4CC-3BC3-CC6E-EBA3A82357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096E55-8F31-605D-7AEA-1576DB368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16E29D-01CB-F47E-590D-57FC9E041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16B9F3-ADDF-4609-DEDD-1BE4B8829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042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541EE-ACBD-5C3A-86CB-24837229D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8D4A94-F71B-9494-C908-F1CBF22684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AB1841-977F-A357-329C-31E726934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47FE38-5EB4-48D0-BF9D-31EF5640E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8BF76-8542-5BBB-08D8-A7CE78A69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825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E6056-E107-5DF5-0688-679D52AD1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AE62D-5367-0F88-A60C-D1CA03C24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8159B9-FA76-EA62-F8A2-B82C7A3C04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372F5E-8C71-57EB-186D-024FF2893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71F086-21CD-D242-320A-B9E820401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60CA2A-5D81-C318-3528-78678266F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562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88F0D-5F74-4034-D997-7C00E0D120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9F928B-06C1-2116-29F0-2A4B05477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47F187-7361-B5B5-DB72-8F53A44023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104573-A76B-CD75-3B84-FCAD831135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0BF9FE-4FD7-53F9-414E-B6B451CDE2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BB51FD-36F8-D868-C533-0CA53B78A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714150-56D9-5FE9-1A76-59EA93147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BC29A8-14EC-3DC0-E91A-1852B8EA1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314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3B5EF3-1B81-F979-5D3E-9BB067CD55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9A93C4-6D1F-0141-5DEB-5212AB246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5B74ADD-4744-429D-CA72-FE5072E6B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0E48A8C-2D0A-CAC6-DB5E-2815F5961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027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77C3DF-5853-F1D6-4804-EC0C42F75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AD14FC-F532-7C6F-ABB7-BF58AC677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04C51F-AE8C-6FEC-879F-C48F57630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216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F8F7B6-DE23-9765-E2B3-B55303287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6FE1D8-6DEE-C663-72A1-45DB7C6595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1AD1BE-9519-D2A8-FE77-AC75757390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9294E6-8705-42A8-9DF1-F58076FB6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078DA3-C927-4E88-0F4B-1F356A01C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A3517E-44D8-6504-43FE-A800FFCEC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500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12B98-9A52-3484-6157-F9580D1CF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F466AC-34AB-5035-E053-7DD7FF1D44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76980D-F30B-C3E7-CF82-F33A188514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045CB-C92B-8DAC-B194-C6823BAB4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E8C841-0CCE-12A9-3776-9491EF446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8D1D7D-90FA-7EB2-C8EF-D7951219D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32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24997F-9BB1-5160-A3C7-00D35FD55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C58C03-8247-566E-AF9D-685F09408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B3D27A-6BCB-51DD-B8B3-10C01A8BEC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344715-41C1-4B53-9F67-53AA5163530F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692215-E130-FF70-9DD0-93FC808967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38C01-6E05-03A7-E51F-C392A65FED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F00C0E-61C8-48DB-8C23-05102591C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224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7B0F9B71-A5A0-0614-5C61-00E17E8AA54D}"/>
              </a:ext>
            </a:extLst>
          </p:cNvPr>
          <p:cNvSpPr txBox="1"/>
          <p:nvPr/>
        </p:nvSpPr>
        <p:spPr>
          <a:xfrm>
            <a:off x="850606" y="5906347"/>
            <a:ext cx="1116418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rrelation between whole plant (Gela et al. 2022; </a:t>
            </a:r>
            <a:r>
              <a:rPr lang="fi-FI" dirty="0">
                <a:latin typeface="Arial" panose="020B0604020202020204" pitchFamily="34" charset="0"/>
                <a:cs typeface="Arial" panose="020B0604020202020204" pitchFamily="34" charset="0"/>
              </a:rPr>
              <a:t>https://doi.org/10.1007/s11032-022-01307-7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and detached leaf assays scores (this study) for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Botrytis faba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sistance (n=159)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868A471-7C25-E497-4197-EDC1AA9450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3028" y="305322"/>
            <a:ext cx="8774107" cy="5096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6618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4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hazaei Hamid (LUKE)</dc:creator>
  <cp:lastModifiedBy>Khazaei Hamid (LUKE)</cp:lastModifiedBy>
  <cp:revision>5</cp:revision>
  <dcterms:created xsi:type="dcterms:W3CDTF">2026-02-11T06:22:20Z</dcterms:created>
  <dcterms:modified xsi:type="dcterms:W3CDTF">2026-03-20T07:24:07Z</dcterms:modified>
</cp:coreProperties>
</file>